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png" ContentType="image/png"/>
  <Override PartName="/ppt/media/image3.png" ContentType="image/png"/>
  <Override PartName="/ppt/media/image4.jpeg" ContentType="image/jpeg"/>
  <Override PartName="/ppt/media/image5.jpeg" ContentType="image/jpe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670675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FAF497-4ADB-4345-A972-F42A323D709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4E5979-8F90-45EC-81AF-783C1EFDDF1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28277C-4CA3-45D7-8A6C-40D2EA9A50D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CCCBF3-08F7-46A4-97D0-1FE2EBBBBE0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091CB7-2E58-4444-9BEE-D1F5D941FC1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C121A1-7105-4CA5-9523-5745123DE7A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B0CD84-BF49-4AFF-910D-CFFC719B516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9776BB-C66A-4AF3-B462-9D43C93A669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9BEA9D-D88D-4C10-A679-6480C3DCBA9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4C55CF-DCFE-49ED-A1E8-A0B7617A38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4F7BD1-9A42-471C-8A9A-933C59B64D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D6725A-C5BA-439E-AC03-603E402F0C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굴림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굴림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굴림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15B35DA-7F5E-45C0-87F0-C8B0EF72B4E1}" type="slidenum">
              <a:rPr b="0" lang="en-US" sz="1400" spc="-1" strike="noStrike">
                <a:solidFill>
                  <a:srgbClr val="000000"/>
                </a:solidFill>
                <a:latin typeface="굴림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oleObject" Target="../embeddings/oleObject1.bin"/><Relationship Id="rId3" Type="http://schemas.openxmlformats.org/officeDocument/2006/relationships/image" Target="../media/image2.png"/><Relationship Id="rId4" Type="http://schemas.openxmlformats.org/officeDocument/2006/relationships/oleObject" Target="../embeddings/oleObject2.bin"/><Relationship Id="rId5" Type="http://schemas.openxmlformats.org/officeDocument/2006/relationships/image" Target="../media/image3.png"/><Relationship Id="rId6" Type="http://schemas.openxmlformats.org/officeDocument/2006/relationships/image" Target="../media/image4.jpeg"/><Relationship Id="rId7" Type="http://schemas.openxmlformats.org/officeDocument/2006/relationships/image" Target="../media/image5.jpeg"/><Relationship Id="rId8" Type="http://schemas.openxmlformats.org/officeDocument/2006/relationships/oleObject" Target="../embeddings/oleObject3.bin"/><Relationship Id="rId9" Type="http://schemas.openxmlformats.org/officeDocument/2006/relationships/image" Target="../media/image6.png"/><Relationship Id="rId10" Type="http://schemas.openxmlformats.org/officeDocument/2006/relationships/image" Target="../media/image7.png"/><Relationship Id="rId11" Type="http://schemas.openxmlformats.org/officeDocument/2006/relationships/image" Target="../media/image8.png"/><Relationship Id="rId12" Type="http://schemas.openxmlformats.org/officeDocument/2006/relationships/oleObject" Target="../embeddings/oleObject4.bin"/><Relationship Id="rId13" Type="http://schemas.openxmlformats.org/officeDocument/2006/relationships/image" Target="../media/image9.png"/><Relationship Id="rId1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3500280" y="2195640"/>
          <a:ext cx="2735280" cy="504720"/>
        </p:xfrm>
        <a:graphic>
          <a:graphicData uri="http://schemas.openxmlformats.org/drawingml/2006/table">
            <a:tbl>
              <a:tblPr/>
              <a:tblGrid>
                <a:gridCol w="592200"/>
                <a:gridCol w="415800"/>
                <a:gridCol w="432000"/>
                <a:gridCol w="431640"/>
                <a:gridCol w="432000"/>
                <a:gridCol w="431640"/>
              </a:tblGrid>
              <a:tr h="176760">
                <a:tc>
                  <a:txBody>
                    <a:bodyPr lIns="18000" rIns="18000" tIns="18000" bIns="180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Tahoma"/>
                        </a:rPr>
                        <a:t>18S rRN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Tahoma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Tahoma"/>
                        </a:rPr>
                        <a:t>1.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Tahoma"/>
                        </a:rPr>
                        <a:t>0.9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Tahoma"/>
                        </a:rPr>
                        <a:t>0.9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Tahoma"/>
                        </a:rPr>
                        <a:t>0.9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6760">
                <a:tc>
                  <a:txBody>
                    <a:bodyPr lIns="18000" rIns="18000" tIns="18000" bIns="180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GAPDH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0.9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0.5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0.9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0.5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6760">
                <a:tc>
                  <a:txBody>
                    <a:bodyPr lIns="18000" rIns="18000" tIns="18000" bIns="180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GAPDH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/18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0.8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0.6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0.9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0.5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"/>
          <p:cNvSpPr/>
          <p:nvPr/>
        </p:nvSpPr>
        <p:spPr>
          <a:xfrm>
            <a:off x="4087800" y="1104840"/>
            <a:ext cx="2147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ahoma"/>
              </a:rPr>
              <a:t>Callus      Root       Leaf      Stem      Spike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43" name="" descr=""/>
          <p:cNvPicPr/>
          <p:nvPr/>
        </p:nvPicPr>
        <p:blipFill>
          <a:blip r:embed="rId1">
            <a:lum contrast="12000"/>
          </a:blip>
          <a:srcRect l="0" t="0" r="0" b="13417"/>
          <a:stretch/>
        </p:blipFill>
        <p:spPr>
          <a:xfrm>
            <a:off x="4075200" y="1593720"/>
            <a:ext cx="2160360" cy="560520"/>
          </a:xfrm>
          <a:prstGeom prst="rect">
            <a:avLst/>
          </a:prstGeom>
          <a:ln w="0">
            <a:noFill/>
          </a:ln>
        </p:spPr>
      </p:pic>
      <p:sp>
        <p:nvSpPr>
          <p:cNvPr id="44" name=""/>
          <p:cNvSpPr/>
          <p:nvPr/>
        </p:nvSpPr>
        <p:spPr>
          <a:xfrm>
            <a:off x="3624840" y="1317600"/>
            <a:ext cx="503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ahoma"/>
                <a:ea typeface="Tahoma"/>
              </a:rPr>
              <a:t>GAPDH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graphicFrame>
        <p:nvGraphicFramePr>
          <p:cNvPr id="45" name=""/>
          <p:cNvGraphicFramePr/>
          <p:nvPr/>
        </p:nvGraphicFramePr>
        <p:xfrm>
          <a:off x="4075200" y="1284120"/>
          <a:ext cx="2162160" cy="284400"/>
        </p:xfrm>
        <a:graphic>
          <a:graphicData uri="http://schemas.openxmlformats.org/presentationml/2006/ole">
            <p:oleObj r:id="rId2" spid="">
              <p:embed/>
              <p:pic>
                <p:nvPicPr>
                  <p:cNvPr id="46" name="" descr=""/>
                  <p:cNvPicPr/>
                  <p:nvPr/>
                </p:nvPicPr>
                <p:blipFill>
                  <a:blip r:embed="rId3"/>
                  <a:stretch/>
                </p:blipFill>
                <p:spPr>
                  <a:xfrm>
                    <a:off x="4075200" y="1284120"/>
                    <a:ext cx="2162160" cy="284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7" name=""/>
          <p:cNvSpPr/>
          <p:nvPr/>
        </p:nvSpPr>
        <p:spPr>
          <a:xfrm>
            <a:off x="3508560" y="1852560"/>
            <a:ext cx="628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ahoma"/>
                <a:ea typeface="Tahoma"/>
              </a:rPr>
              <a:t>18S rRNA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8" name=""/>
          <p:cNvSpPr/>
          <p:nvPr/>
        </p:nvSpPr>
        <p:spPr>
          <a:xfrm>
            <a:off x="3508560" y="1654200"/>
            <a:ext cx="628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ahoma"/>
                <a:ea typeface="Tahoma"/>
              </a:rPr>
              <a:t>28S rRNA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graphicFrame>
        <p:nvGraphicFramePr>
          <p:cNvPr id="49" name=""/>
          <p:cNvGraphicFramePr/>
          <p:nvPr/>
        </p:nvGraphicFramePr>
        <p:xfrm>
          <a:off x="1197000" y="1276200"/>
          <a:ext cx="2160720" cy="287640"/>
        </p:xfrm>
        <a:graphic>
          <a:graphicData uri="http://schemas.openxmlformats.org/presentationml/2006/ole">
            <p:oleObj r:id="rId4" spid="">
              <p:embed/>
              <p:pic>
                <p:nvPicPr>
                  <p:cNvPr id="50" name="" descr=""/>
                  <p:cNvPicPr/>
                  <p:nvPr/>
                </p:nvPicPr>
                <p:blipFill>
                  <a:blip r:embed="rId5"/>
                  <a:stretch/>
                </p:blipFill>
                <p:spPr>
                  <a:xfrm>
                    <a:off x="1197000" y="1276200"/>
                    <a:ext cx="2160720" cy="287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1" name=""/>
          <p:cNvSpPr/>
          <p:nvPr/>
        </p:nvSpPr>
        <p:spPr>
          <a:xfrm>
            <a:off x="1237680" y="1093680"/>
            <a:ext cx="2137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ahoma"/>
                <a:ea typeface="Tahoma"/>
              </a:rPr>
              <a:t>Mock       Salt       Cold       Heat     Drought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52" name="" descr=""/>
          <p:cNvPicPr/>
          <p:nvPr/>
        </p:nvPicPr>
        <p:blipFill>
          <a:blip r:embed="rId6">
            <a:lum contrast="12000"/>
          </a:blip>
          <a:srcRect l="0" t="9161" r="0" b="16781"/>
          <a:stretch/>
        </p:blipFill>
        <p:spPr>
          <a:xfrm>
            <a:off x="1197000" y="1595520"/>
            <a:ext cx="2160720" cy="557280"/>
          </a:xfrm>
          <a:prstGeom prst="rect">
            <a:avLst/>
          </a:prstGeom>
          <a:ln w="0">
            <a:noFill/>
          </a:ln>
        </p:spPr>
      </p:pic>
      <p:sp>
        <p:nvSpPr>
          <p:cNvPr id="53" name=""/>
          <p:cNvSpPr/>
          <p:nvPr/>
        </p:nvSpPr>
        <p:spPr>
          <a:xfrm>
            <a:off x="753120" y="1301760"/>
            <a:ext cx="503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ahoma"/>
                <a:ea typeface="Tahoma"/>
              </a:rPr>
              <a:t>GAPDH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4" name=""/>
          <p:cNvSpPr/>
          <p:nvPr/>
        </p:nvSpPr>
        <p:spPr>
          <a:xfrm>
            <a:off x="649440" y="1817640"/>
            <a:ext cx="628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ahoma"/>
                <a:ea typeface="Tahoma"/>
              </a:rPr>
              <a:t>18S rRNA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5" name=""/>
          <p:cNvSpPr/>
          <p:nvPr/>
        </p:nvSpPr>
        <p:spPr>
          <a:xfrm>
            <a:off x="649440" y="1619280"/>
            <a:ext cx="628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ahoma"/>
                <a:ea typeface="Tahoma"/>
              </a:rPr>
              <a:t>28S rRNA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graphicFrame>
        <p:nvGraphicFramePr>
          <p:cNvPr id="56" name=""/>
          <p:cNvGraphicFramePr/>
          <p:nvPr/>
        </p:nvGraphicFramePr>
        <p:xfrm>
          <a:off x="620640" y="2190600"/>
          <a:ext cx="2737080" cy="504720"/>
        </p:xfrm>
        <a:graphic>
          <a:graphicData uri="http://schemas.openxmlformats.org/drawingml/2006/table">
            <a:tbl>
              <a:tblPr/>
              <a:tblGrid>
                <a:gridCol w="647640"/>
                <a:gridCol w="432000"/>
                <a:gridCol w="395280"/>
                <a:gridCol w="420480"/>
                <a:gridCol w="420840"/>
                <a:gridCol w="420840"/>
              </a:tblGrid>
              <a:tr h="168120">
                <a:tc>
                  <a:txBody>
                    <a:bodyPr lIns="18000" rIns="18000" tIns="18000" bIns="180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Tahoma"/>
                        </a:rPr>
                        <a:t>18S rRN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Tahoma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Tahoma"/>
                        </a:rPr>
                        <a:t>1.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Tahoma"/>
                        </a:rPr>
                        <a:t>0.9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Tahoma"/>
                        </a:rPr>
                        <a:t>0.9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Tahoma"/>
                        </a:rPr>
                        <a:t>1.0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8480">
                <a:tc>
                  <a:txBody>
                    <a:bodyPr lIns="18000" rIns="18000" tIns="18000" bIns="180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GAPDH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1.0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1.0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1.0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1.0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8120">
                <a:tc>
                  <a:txBody>
                    <a:bodyPr lIns="18000" rIns="18000" tIns="18000" bIns="180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GAPDH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/18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0.8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1.0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1.0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0.9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7" name=""/>
          <p:cNvSpPr/>
          <p:nvPr/>
        </p:nvSpPr>
        <p:spPr>
          <a:xfrm>
            <a:off x="1238400" y="2771640"/>
            <a:ext cx="3781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ahoma"/>
                <a:ea typeface="Tahoma"/>
              </a:rPr>
              <a:t>Mock       IAA        ABA       ACC        GA       Zeatin       SA         BL        MeJA  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58" name="" descr=""/>
          <p:cNvPicPr/>
          <p:nvPr/>
        </p:nvPicPr>
        <p:blipFill>
          <a:blip r:embed="rId7"/>
          <a:srcRect l="0" t="14177" r="0" b="22409"/>
          <a:stretch/>
        </p:blipFill>
        <p:spPr>
          <a:xfrm>
            <a:off x="1203480" y="3268800"/>
            <a:ext cx="3816360" cy="57600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59" name=""/>
          <p:cNvGraphicFramePr/>
          <p:nvPr/>
        </p:nvGraphicFramePr>
        <p:xfrm>
          <a:off x="1203480" y="2952720"/>
          <a:ext cx="3816360" cy="289080"/>
        </p:xfrm>
        <a:graphic>
          <a:graphicData uri="http://schemas.openxmlformats.org/presentationml/2006/ole">
            <p:oleObj r:id="rId8" spid="">
              <p:embed/>
              <p:pic>
                <p:nvPicPr>
                  <p:cNvPr id="60" name="" descr=""/>
                  <p:cNvPicPr/>
                  <p:nvPr/>
                </p:nvPicPr>
                <p:blipFill>
                  <a:blip r:embed="rId9"/>
                  <a:stretch/>
                </p:blipFill>
                <p:spPr>
                  <a:xfrm>
                    <a:off x="1203480" y="2952720"/>
                    <a:ext cx="3816360" cy="2890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1" name=""/>
          <p:cNvGraphicFramePr/>
          <p:nvPr/>
        </p:nvGraphicFramePr>
        <p:xfrm>
          <a:off x="627120" y="3889440"/>
          <a:ext cx="4392360" cy="471600"/>
        </p:xfrm>
        <a:graphic>
          <a:graphicData uri="http://schemas.openxmlformats.org/drawingml/2006/table">
            <a:tbl>
              <a:tblPr/>
              <a:tblGrid>
                <a:gridCol w="587160"/>
                <a:gridCol w="420840"/>
                <a:gridCol w="431640"/>
                <a:gridCol w="433440"/>
                <a:gridCol w="432000"/>
                <a:gridCol w="431640"/>
                <a:gridCol w="431640"/>
                <a:gridCol w="432000"/>
                <a:gridCol w="425520"/>
                <a:gridCol w="366480"/>
              </a:tblGrid>
              <a:tr h="158040">
                <a:tc>
                  <a:txBody>
                    <a:bodyPr lIns="18000" rIns="18000" tIns="18000" bIns="180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18S rRN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1.0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1.1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1.2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1.0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1.2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1.2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1.2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0.9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>
                  <a:txBody>
                    <a:bodyPr lIns="18000" rIns="18000" tIns="18000" bIns="180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GAPDH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1.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1.0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1.0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0.9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1.0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1.1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0.9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0.9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>
                  <a:txBody>
                    <a:bodyPr lIns="18000" rIns="18000" tIns="18000" bIns="180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GAPDH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/18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0.9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0.9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0.8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0.9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0.9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0.9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0.8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0.9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pic>
        <p:nvPicPr>
          <p:cNvPr id="62" name="" descr=""/>
          <p:cNvPicPr/>
          <p:nvPr/>
        </p:nvPicPr>
        <p:blipFill>
          <a:blip r:embed="rId10"/>
          <a:srcRect l="9401" t="15133" r="3785" b="11973"/>
          <a:stretch/>
        </p:blipFill>
        <p:spPr>
          <a:xfrm>
            <a:off x="1266840" y="4498920"/>
            <a:ext cx="2665440" cy="167976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pic>
        <p:nvPicPr>
          <p:cNvPr id="63" name="" descr=""/>
          <p:cNvPicPr/>
          <p:nvPr/>
        </p:nvPicPr>
        <p:blipFill>
          <a:blip r:embed="rId11"/>
          <a:srcRect l="3803" t="9498" r="3803" b="15521"/>
          <a:stretch/>
        </p:blipFill>
        <p:spPr>
          <a:xfrm>
            <a:off x="1647720" y="6784920"/>
            <a:ext cx="1728720" cy="576360"/>
          </a:xfrm>
          <a:prstGeom prst="rect">
            <a:avLst/>
          </a:prstGeom>
          <a:ln w="0">
            <a:noFill/>
          </a:ln>
        </p:spPr>
      </p:pic>
      <p:sp>
        <p:nvSpPr>
          <p:cNvPr id="64" name=""/>
          <p:cNvSpPr/>
          <p:nvPr/>
        </p:nvSpPr>
        <p:spPr>
          <a:xfrm>
            <a:off x="1744560" y="6300720"/>
            <a:ext cx="1631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ahoma"/>
              </a:rPr>
              <a:t>1            2           3            4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graphicFrame>
        <p:nvGraphicFramePr>
          <p:cNvPr id="65" name=""/>
          <p:cNvGraphicFramePr/>
          <p:nvPr/>
        </p:nvGraphicFramePr>
        <p:xfrm>
          <a:off x="1647720" y="6464160"/>
          <a:ext cx="1727280" cy="289080"/>
        </p:xfrm>
        <a:graphic>
          <a:graphicData uri="http://schemas.openxmlformats.org/presentationml/2006/ole">
            <p:oleObj r:id="rId12" spid="">
              <p:embed/>
              <p:pic>
                <p:nvPicPr>
                  <p:cNvPr id="66" name="" descr=""/>
                  <p:cNvPicPr/>
                  <p:nvPr/>
                </p:nvPicPr>
                <p:blipFill>
                  <a:blip r:embed="rId13"/>
                  <a:stretch/>
                </p:blipFill>
                <p:spPr>
                  <a:xfrm>
                    <a:off x="1647720" y="6464160"/>
                    <a:ext cx="1727280" cy="2890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7" name=""/>
          <p:cNvSpPr/>
          <p:nvPr/>
        </p:nvSpPr>
        <p:spPr>
          <a:xfrm>
            <a:off x="759240" y="3030480"/>
            <a:ext cx="503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ahoma"/>
                <a:ea typeface="Tahoma"/>
              </a:rPr>
              <a:t>GAPDH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8" name=""/>
          <p:cNvSpPr/>
          <p:nvPr/>
        </p:nvSpPr>
        <p:spPr>
          <a:xfrm>
            <a:off x="642960" y="3456000"/>
            <a:ext cx="628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ahoma"/>
                <a:ea typeface="Tahoma"/>
              </a:rPr>
              <a:t>18S rRNA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9" name=""/>
          <p:cNvSpPr/>
          <p:nvPr/>
        </p:nvSpPr>
        <p:spPr>
          <a:xfrm>
            <a:off x="642960" y="3257640"/>
            <a:ext cx="628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ahoma"/>
                <a:ea typeface="Tahoma"/>
              </a:rPr>
              <a:t>28S rRNA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0" name=""/>
          <p:cNvSpPr/>
          <p:nvPr/>
        </p:nvSpPr>
        <p:spPr>
          <a:xfrm>
            <a:off x="1195920" y="6489720"/>
            <a:ext cx="503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ahoma"/>
                <a:ea typeface="Tahoma"/>
              </a:rPr>
              <a:t>GAPDH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1" name=""/>
          <p:cNvSpPr/>
          <p:nvPr/>
        </p:nvSpPr>
        <p:spPr>
          <a:xfrm>
            <a:off x="1079640" y="7024680"/>
            <a:ext cx="628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ahoma"/>
                <a:ea typeface="Tahoma"/>
              </a:rPr>
              <a:t>18S rRNA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2" name=""/>
          <p:cNvSpPr/>
          <p:nvPr/>
        </p:nvSpPr>
        <p:spPr>
          <a:xfrm>
            <a:off x="1079640" y="6826320"/>
            <a:ext cx="628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ahoma"/>
                <a:ea typeface="Tahoma"/>
              </a:rPr>
              <a:t>28S rRNA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grpSp>
        <p:nvGrpSpPr>
          <p:cNvPr id="73" name=""/>
          <p:cNvGrpSpPr/>
          <p:nvPr/>
        </p:nvGrpSpPr>
        <p:grpSpPr>
          <a:xfrm>
            <a:off x="1484280" y="6226200"/>
            <a:ext cx="1800360" cy="146160"/>
            <a:chOff x="1484280" y="6226200"/>
            <a:chExt cx="1800360" cy="146160"/>
          </a:xfrm>
        </p:grpSpPr>
        <p:sp>
          <p:nvSpPr>
            <p:cNvPr id="74" name=""/>
            <p:cNvSpPr/>
            <p:nvPr/>
          </p:nvSpPr>
          <p:spPr>
            <a:xfrm>
              <a:off x="1484280" y="6226200"/>
              <a:ext cx="289080" cy="146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2060640" y="6226200"/>
              <a:ext cx="216000" cy="146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2637000" y="6226200"/>
              <a:ext cx="71280" cy="146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77" name=""/>
            <p:cNvSpPr/>
            <p:nvPr/>
          </p:nvSpPr>
          <p:spPr>
            <a:xfrm flipH="1">
              <a:off x="3139920" y="6226200"/>
              <a:ext cx="144720" cy="146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  <p:graphicFrame>
        <p:nvGraphicFramePr>
          <p:cNvPr id="78" name=""/>
          <p:cNvGraphicFramePr/>
          <p:nvPr/>
        </p:nvGraphicFramePr>
        <p:xfrm>
          <a:off x="907920" y="7402680"/>
          <a:ext cx="2462400" cy="471240"/>
        </p:xfrm>
        <a:graphic>
          <a:graphicData uri="http://schemas.openxmlformats.org/drawingml/2006/table">
            <a:tbl>
              <a:tblPr/>
              <a:tblGrid>
                <a:gridCol w="709560"/>
                <a:gridCol w="438120"/>
                <a:gridCol w="438120"/>
                <a:gridCol w="438120"/>
                <a:gridCol w="438480"/>
              </a:tblGrid>
              <a:tr h="158040">
                <a:tc>
                  <a:txBody>
                    <a:bodyPr lIns="18000" rIns="18000" tIns="18000" bIns="180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18S rRN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0.8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0.9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0.8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>
                  <a:txBody>
                    <a:bodyPr lIns="18000" rIns="18000" tIns="18000" bIns="180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GAPDH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0.9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0.7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0.7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>
                  <a:txBody>
                    <a:bodyPr lIns="18000" rIns="18000" tIns="18000" bIns="180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GAPDH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/18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1.1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0.8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ahoma"/>
                          <a:ea typeface="Arial"/>
                        </a:rPr>
                        <a:t>0.8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18000" marR="18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79" name=""/>
          <p:cNvSpPr/>
          <p:nvPr/>
        </p:nvSpPr>
        <p:spPr>
          <a:xfrm>
            <a:off x="4028040" y="4824360"/>
            <a:ext cx="1346760" cy="7261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3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ahoma"/>
                <a:ea typeface="Tahoma"/>
              </a:rPr>
              <a:t>1 Early Vegetative phase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13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ahoma"/>
                <a:ea typeface="Tahoma"/>
              </a:rPr>
              <a:t>2 Late Vegetative phase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13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ahoma"/>
                <a:ea typeface="Tahoma"/>
              </a:rPr>
              <a:t>3 Transition phase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13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ahoma"/>
                <a:ea typeface="Tahoma"/>
              </a:rPr>
              <a:t>4 Reproductive phase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0" name=""/>
          <p:cNvSpPr/>
          <p:nvPr/>
        </p:nvSpPr>
        <p:spPr>
          <a:xfrm>
            <a:off x="497520" y="1093680"/>
            <a:ext cx="328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ahoma"/>
                <a:ea typeface="Tahoma"/>
              </a:rPr>
              <a:t>(a)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1" name=""/>
          <p:cNvSpPr/>
          <p:nvPr/>
        </p:nvSpPr>
        <p:spPr>
          <a:xfrm>
            <a:off x="3366360" y="1093680"/>
            <a:ext cx="33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ahoma"/>
                <a:ea typeface="Tahoma"/>
              </a:rPr>
              <a:t>(b)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2" name=""/>
          <p:cNvSpPr/>
          <p:nvPr/>
        </p:nvSpPr>
        <p:spPr>
          <a:xfrm>
            <a:off x="487800" y="2743200"/>
            <a:ext cx="317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ahoma"/>
                <a:ea typeface="Tahoma"/>
              </a:rPr>
              <a:t>(c)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3" name=""/>
          <p:cNvSpPr/>
          <p:nvPr/>
        </p:nvSpPr>
        <p:spPr>
          <a:xfrm>
            <a:off x="484920" y="4356000"/>
            <a:ext cx="33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ahoma"/>
                <a:ea typeface="Tahoma"/>
              </a:rPr>
              <a:t>(d)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FE6E22-B4D2-4E03-9D64-9A77CD4A037A}" type="slidenum">
              <a:t>1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6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5-22T06:18:19Z</dcterms:created>
  <dc:creator>박충모</dc:creator>
  <dc:description/>
  <dc:language>en-US</dc:language>
  <cp:lastModifiedBy>박충모</cp:lastModifiedBy>
  <dcterms:modified xsi:type="dcterms:W3CDTF">2008-11-04T00:45:37Z</dcterms:modified>
  <cp:revision>30</cp:revision>
  <dc:subject/>
  <dc:title>슬라이드 1</dc:title>
</cp:coreProperties>
</file>